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  <p:sldId id="276" r:id="rId3"/>
    <p:sldId id="273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60F7F7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F4F391E-F15E-4E7D-9CC3-EDAD1CBB2E3B}" v="17" dt="2024-03-20T05:58:48.5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5090" autoAdjust="0"/>
  </p:normalViewPr>
  <p:slideViewPr>
    <p:cSldViewPr snapToGrid="0">
      <p:cViewPr varScale="1">
        <p:scale>
          <a:sx n="112" d="100"/>
          <a:sy n="112" d="100"/>
        </p:scale>
        <p:origin x="76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정가영" userId="8dd6b78c-8fdb-47ca-9782-fb56b898c718" providerId="ADAL" clId="{7F4F391E-F15E-4E7D-9CC3-EDAD1CBB2E3B}"/>
    <pc:docChg chg="custSel addSld delSld modSld">
      <pc:chgData name="정가영" userId="8dd6b78c-8fdb-47ca-9782-fb56b898c718" providerId="ADAL" clId="{7F4F391E-F15E-4E7D-9CC3-EDAD1CBB2E3B}" dt="2024-03-20T05:59:17.169" v="76" actId="478"/>
      <pc:docMkLst>
        <pc:docMk/>
      </pc:docMkLst>
      <pc:sldChg chg="del">
        <pc:chgData name="정가영" userId="8dd6b78c-8fdb-47ca-9782-fb56b898c718" providerId="ADAL" clId="{7F4F391E-F15E-4E7D-9CC3-EDAD1CBB2E3B}" dt="2024-03-20T02:12:35.498" v="7" actId="47"/>
        <pc:sldMkLst>
          <pc:docMk/>
          <pc:sldMk cId="2193840776" sldId="272"/>
        </pc:sldMkLst>
      </pc:sldChg>
      <pc:sldChg chg="delSp modSp add del mod modShow">
        <pc:chgData name="정가영" userId="8dd6b78c-8fdb-47ca-9782-fb56b898c718" providerId="ADAL" clId="{7F4F391E-F15E-4E7D-9CC3-EDAD1CBB2E3B}" dt="2024-03-20T05:59:08.734" v="71" actId="478"/>
        <pc:sldMkLst>
          <pc:docMk/>
          <pc:sldMk cId="594898383" sldId="273"/>
        </pc:sldMkLst>
        <pc:spChg chg="del">
          <ac:chgData name="정가영" userId="8dd6b78c-8fdb-47ca-9782-fb56b898c718" providerId="ADAL" clId="{7F4F391E-F15E-4E7D-9CC3-EDAD1CBB2E3B}" dt="2024-03-20T05:59:08.734" v="71" actId="478"/>
          <ac:spMkLst>
            <pc:docMk/>
            <pc:sldMk cId="594898383" sldId="273"/>
            <ac:spMk id="4" creationId="{8692C3EF-7AE8-0FAB-4633-838F275BF9E9}"/>
          </ac:spMkLst>
        </pc:spChg>
        <pc:spChg chg="mod">
          <ac:chgData name="정가영" userId="8dd6b78c-8fdb-47ca-9782-fb56b898c718" providerId="ADAL" clId="{7F4F391E-F15E-4E7D-9CC3-EDAD1CBB2E3B}" dt="2024-03-20T05:59:01.330" v="69" actId="20577"/>
          <ac:spMkLst>
            <pc:docMk/>
            <pc:sldMk cId="594898383" sldId="273"/>
            <ac:spMk id="18" creationId="{6B0BA2F4-E49E-BCFA-2497-4692F75BF2CB}"/>
          </ac:spMkLst>
        </pc:spChg>
      </pc:sldChg>
      <pc:sldChg chg="delSp modSp mod">
        <pc:chgData name="정가영" userId="8dd6b78c-8fdb-47ca-9782-fb56b898c718" providerId="ADAL" clId="{7F4F391E-F15E-4E7D-9CC3-EDAD1CBB2E3B}" dt="2024-03-20T05:59:12.259" v="73" actId="478"/>
        <pc:sldMkLst>
          <pc:docMk/>
          <pc:sldMk cId="2530487145" sldId="274"/>
        </pc:sldMkLst>
        <pc:spChg chg="del">
          <ac:chgData name="정가영" userId="8dd6b78c-8fdb-47ca-9782-fb56b898c718" providerId="ADAL" clId="{7F4F391E-F15E-4E7D-9CC3-EDAD1CBB2E3B}" dt="2024-03-20T05:59:12.259" v="73" actId="478"/>
          <ac:spMkLst>
            <pc:docMk/>
            <pc:sldMk cId="2530487145" sldId="274"/>
            <ac:spMk id="11" creationId="{2AF84DBC-42E3-A614-6253-A55B63D3F2FA}"/>
          </ac:spMkLst>
        </pc:spChg>
        <pc:spChg chg="mod">
          <ac:chgData name="정가영" userId="8dd6b78c-8fdb-47ca-9782-fb56b898c718" providerId="ADAL" clId="{7F4F391E-F15E-4E7D-9CC3-EDAD1CBB2E3B}" dt="2024-03-20T04:42:38.143" v="67" actId="20577"/>
          <ac:spMkLst>
            <pc:docMk/>
            <pc:sldMk cId="2530487145" sldId="274"/>
            <ac:spMk id="19" creationId="{2BDB48AB-A731-4AB1-4600-44F4EC86FEBE}"/>
          </ac:spMkLst>
        </pc:spChg>
      </pc:sldChg>
      <pc:sldChg chg="del">
        <pc:chgData name="정가영" userId="8dd6b78c-8fdb-47ca-9782-fb56b898c718" providerId="ADAL" clId="{7F4F391E-F15E-4E7D-9CC3-EDAD1CBB2E3B}" dt="2024-03-20T02:12:37.332" v="8" actId="47"/>
        <pc:sldMkLst>
          <pc:docMk/>
          <pc:sldMk cId="486735605" sldId="275"/>
        </pc:sldMkLst>
      </pc:sldChg>
      <pc:sldChg chg="delSp modSp mod">
        <pc:chgData name="정가영" userId="8dd6b78c-8fdb-47ca-9782-fb56b898c718" providerId="ADAL" clId="{7F4F391E-F15E-4E7D-9CC3-EDAD1CBB2E3B}" dt="2024-03-20T05:59:17.169" v="76" actId="478"/>
        <pc:sldMkLst>
          <pc:docMk/>
          <pc:sldMk cId="383289393" sldId="276"/>
        </pc:sldMkLst>
        <pc:spChg chg="del">
          <ac:chgData name="정가영" userId="8dd6b78c-8fdb-47ca-9782-fb56b898c718" providerId="ADAL" clId="{7F4F391E-F15E-4E7D-9CC3-EDAD1CBB2E3B}" dt="2024-03-20T05:59:14.400" v="74" actId="478"/>
          <ac:spMkLst>
            <pc:docMk/>
            <pc:sldMk cId="383289393" sldId="276"/>
            <ac:spMk id="5" creationId="{82DDD937-FDB2-90A8-D0C1-C5559EACFAC8}"/>
          </ac:spMkLst>
        </pc:spChg>
        <pc:spChg chg="del">
          <ac:chgData name="정가영" userId="8dd6b78c-8fdb-47ca-9782-fb56b898c718" providerId="ADAL" clId="{7F4F391E-F15E-4E7D-9CC3-EDAD1CBB2E3B}" dt="2024-03-20T05:59:16.042" v="75" actId="478"/>
          <ac:spMkLst>
            <pc:docMk/>
            <pc:sldMk cId="383289393" sldId="276"/>
            <ac:spMk id="6" creationId="{2151BE22-71F0-FFE9-10E1-60D4792E0851}"/>
          </ac:spMkLst>
        </pc:spChg>
        <pc:spChg chg="del">
          <ac:chgData name="정가영" userId="8dd6b78c-8fdb-47ca-9782-fb56b898c718" providerId="ADAL" clId="{7F4F391E-F15E-4E7D-9CC3-EDAD1CBB2E3B}" dt="2024-03-20T05:59:17.169" v="76" actId="478"/>
          <ac:spMkLst>
            <pc:docMk/>
            <pc:sldMk cId="383289393" sldId="276"/>
            <ac:spMk id="7" creationId="{22CC50AE-3FAE-AF37-40A3-6A163995C603}"/>
          </ac:spMkLst>
        </pc:spChg>
        <pc:spChg chg="del">
          <ac:chgData name="정가영" userId="8dd6b78c-8fdb-47ca-9782-fb56b898c718" providerId="ADAL" clId="{7F4F391E-F15E-4E7D-9CC3-EDAD1CBB2E3B}" dt="2024-03-20T05:59:10.500" v="72" actId="478"/>
          <ac:spMkLst>
            <pc:docMk/>
            <pc:sldMk cId="383289393" sldId="276"/>
            <ac:spMk id="11" creationId="{2AF84DBC-42E3-A614-6253-A55B63D3F2FA}"/>
          </ac:spMkLst>
        </pc:spChg>
        <pc:spChg chg="mod">
          <ac:chgData name="정가영" userId="8dd6b78c-8fdb-47ca-9782-fb56b898c718" providerId="ADAL" clId="{7F4F391E-F15E-4E7D-9CC3-EDAD1CBB2E3B}" dt="2024-03-20T04:27:32.677" v="46" actId="1035"/>
          <ac:spMkLst>
            <pc:docMk/>
            <pc:sldMk cId="383289393" sldId="276"/>
            <ac:spMk id="15" creationId="{47F4F222-001D-D5A7-3958-B1699525DC3D}"/>
          </ac:spMkLst>
        </pc:spChg>
        <pc:spChg chg="mod">
          <ac:chgData name="정가영" userId="8dd6b78c-8fdb-47ca-9782-fb56b898c718" providerId="ADAL" clId="{7F4F391E-F15E-4E7D-9CC3-EDAD1CBB2E3B}" dt="2024-03-20T04:42:31.432" v="66" actId="20577"/>
          <ac:spMkLst>
            <pc:docMk/>
            <pc:sldMk cId="383289393" sldId="276"/>
            <ac:spMk id="19" creationId="{2BDB48AB-A731-4AB1-4600-44F4EC86FEBE}"/>
          </ac:spMkLst>
        </pc:spChg>
        <pc:spChg chg="mod">
          <ac:chgData name="정가영" userId="8dd6b78c-8fdb-47ca-9782-fb56b898c718" providerId="ADAL" clId="{7F4F391E-F15E-4E7D-9CC3-EDAD1CBB2E3B}" dt="2024-03-20T04:27:32.677" v="46" actId="1035"/>
          <ac:spMkLst>
            <pc:docMk/>
            <pc:sldMk cId="383289393" sldId="276"/>
            <ac:spMk id="20" creationId="{542BF94D-ADCC-DAB6-9AD5-303180BDE3FD}"/>
          </ac:spMkLst>
        </pc:spChg>
        <pc:spChg chg="del">
          <ac:chgData name="정가영" userId="8dd6b78c-8fdb-47ca-9782-fb56b898c718" providerId="ADAL" clId="{7F4F391E-F15E-4E7D-9CC3-EDAD1CBB2E3B}" dt="2024-03-20T04:30:46.972" v="48" actId="478"/>
          <ac:spMkLst>
            <pc:docMk/>
            <pc:sldMk cId="383289393" sldId="276"/>
            <ac:spMk id="29" creationId="{9322A8BB-E331-1744-1DF6-2C6014EDB0D8}"/>
          </ac:spMkLst>
        </pc:spChg>
        <pc:graphicFrameChg chg="mod">
          <ac:chgData name="정가영" userId="8dd6b78c-8fdb-47ca-9782-fb56b898c718" providerId="ADAL" clId="{7F4F391E-F15E-4E7D-9CC3-EDAD1CBB2E3B}" dt="2024-03-20T04:25:45.331" v="11"/>
          <ac:graphicFrameMkLst>
            <pc:docMk/>
            <pc:sldMk cId="383289393" sldId="276"/>
            <ac:graphicFrameMk id="16" creationId="{2D8434A6-1924-3353-CB42-C433E192AA56}"/>
          </ac:graphicFrameMkLst>
        </pc:graphicFrameChg>
        <pc:graphicFrameChg chg="del">
          <ac:chgData name="정가영" userId="8dd6b78c-8fdb-47ca-9782-fb56b898c718" providerId="ADAL" clId="{7F4F391E-F15E-4E7D-9CC3-EDAD1CBB2E3B}" dt="2024-03-20T02:12:20.418" v="0" actId="478"/>
          <ac:graphicFrameMkLst>
            <pc:docMk/>
            <pc:sldMk cId="383289393" sldId="276"/>
            <ac:graphicFrameMk id="17" creationId="{122C24E7-4511-1716-4306-5A654F1340CE}"/>
          </ac:graphicFrameMkLst>
        </pc:graphicFrameChg>
        <pc:graphicFrameChg chg="mod">
          <ac:chgData name="정가영" userId="8dd6b78c-8fdb-47ca-9782-fb56b898c718" providerId="ADAL" clId="{7F4F391E-F15E-4E7D-9CC3-EDAD1CBB2E3B}" dt="2024-03-20T04:26:40.232" v="14"/>
          <ac:graphicFrameMkLst>
            <pc:docMk/>
            <pc:sldMk cId="383289393" sldId="276"/>
            <ac:graphicFrameMk id="18" creationId="{B4CD90ED-70F1-8648-FFC7-36B4ECD47DE3}"/>
          </ac:graphicFrameMkLst>
        </pc:graphicFrameChg>
        <pc:graphicFrameChg chg="del">
          <ac:chgData name="정가영" userId="8dd6b78c-8fdb-47ca-9782-fb56b898c718" providerId="ADAL" clId="{7F4F391E-F15E-4E7D-9CC3-EDAD1CBB2E3B}" dt="2024-03-20T02:12:23.297" v="4" actId="478"/>
          <ac:graphicFrameMkLst>
            <pc:docMk/>
            <pc:sldMk cId="383289393" sldId="276"/>
            <ac:graphicFrameMk id="22" creationId="{680EFC71-3973-EAB6-CA40-5BEAE1EDFF96}"/>
          </ac:graphicFrameMkLst>
        </pc:graphicFrameChg>
        <pc:graphicFrameChg chg="del">
          <ac:chgData name="정가영" userId="8dd6b78c-8fdb-47ca-9782-fb56b898c718" providerId="ADAL" clId="{7F4F391E-F15E-4E7D-9CC3-EDAD1CBB2E3B}" dt="2024-03-20T02:12:22.540" v="3" actId="478"/>
          <ac:graphicFrameMkLst>
            <pc:docMk/>
            <pc:sldMk cId="383289393" sldId="276"/>
            <ac:graphicFrameMk id="23" creationId="{DA6206DF-2DAF-8F02-E429-2B2B2CA94CFC}"/>
          </ac:graphicFrameMkLst>
        </pc:graphicFrameChg>
        <pc:graphicFrameChg chg="del">
          <ac:chgData name="정가영" userId="8dd6b78c-8fdb-47ca-9782-fb56b898c718" providerId="ADAL" clId="{7F4F391E-F15E-4E7D-9CC3-EDAD1CBB2E3B}" dt="2024-03-20T02:12:21.378" v="1" actId="478"/>
          <ac:graphicFrameMkLst>
            <pc:docMk/>
            <pc:sldMk cId="383289393" sldId="276"/>
            <ac:graphicFrameMk id="24" creationId="{7B14FDC4-24D3-259A-BF3D-81F6A37F1DE9}"/>
          </ac:graphicFrameMkLst>
        </pc:graphicFrameChg>
        <pc:graphicFrameChg chg="del">
          <ac:chgData name="정가영" userId="8dd6b78c-8fdb-47ca-9782-fb56b898c718" providerId="ADAL" clId="{7F4F391E-F15E-4E7D-9CC3-EDAD1CBB2E3B}" dt="2024-03-20T02:12:21.948" v="2" actId="478"/>
          <ac:graphicFrameMkLst>
            <pc:docMk/>
            <pc:sldMk cId="383289393" sldId="276"/>
            <ac:graphicFrameMk id="25" creationId="{A4BE000F-E875-0B8A-8178-C7D438DABB7F}"/>
          </ac:graphicFrameMkLst>
        </pc:graphicFrameChg>
        <pc:graphicFrameChg chg="mod">
          <ac:chgData name="정가영" userId="8dd6b78c-8fdb-47ca-9782-fb56b898c718" providerId="ADAL" clId="{7F4F391E-F15E-4E7D-9CC3-EDAD1CBB2E3B}" dt="2024-03-20T04:42:24.056" v="65"/>
          <ac:graphicFrameMkLst>
            <pc:docMk/>
            <pc:sldMk cId="383289393" sldId="276"/>
            <ac:graphicFrameMk id="26" creationId="{423DB5BA-4B19-EA35-93BD-23150858346E}"/>
          </ac:graphicFrameMkLst>
        </pc:graphicFrameChg>
        <pc:graphicFrameChg chg="del mod">
          <ac:chgData name="정가영" userId="8dd6b78c-8fdb-47ca-9782-fb56b898c718" providerId="ADAL" clId="{7F4F391E-F15E-4E7D-9CC3-EDAD1CBB2E3B}" dt="2024-03-20T04:30:44.099" v="47" actId="478"/>
          <ac:graphicFrameMkLst>
            <pc:docMk/>
            <pc:sldMk cId="383289393" sldId="276"/>
            <ac:graphicFrameMk id="27" creationId="{D5CE4645-5B5C-B6EA-ED61-A87885003BF9}"/>
          </ac:graphicFrameMkLst>
        </pc:graphicFrameChg>
        <pc:picChg chg="del">
          <ac:chgData name="정가영" userId="8dd6b78c-8fdb-47ca-9782-fb56b898c718" providerId="ADAL" clId="{7F4F391E-F15E-4E7D-9CC3-EDAD1CBB2E3B}" dt="2024-03-20T02:12:24.310" v="5" actId="478"/>
          <ac:picMkLst>
            <pc:docMk/>
            <pc:sldMk cId="383289393" sldId="276"/>
            <ac:picMk id="21" creationId="{E75C15D5-DF17-4490-044F-9A24C60966DD}"/>
          </ac:picMkLst>
        </pc:picChg>
      </pc:sldChg>
    </pc:docChg>
  </pc:docChgLst>
  <pc:docChgLst>
    <pc:chgData name="정가영" userId="8dd6b78c-8fdb-47ca-9782-fb56b898c718" providerId="ADAL" clId="{932335E3-9B28-475D-829D-65FC9C058729}"/>
    <pc:docChg chg="modSld">
      <pc:chgData name="정가영" userId="8dd6b78c-8fdb-47ca-9782-fb56b898c718" providerId="ADAL" clId="{932335E3-9B28-475D-829D-65FC9C058729}" dt="2024-03-19T04:48:56.347" v="1" actId="20577"/>
      <pc:docMkLst>
        <pc:docMk/>
      </pc:docMkLst>
      <pc:sldChg chg="modSp mod">
        <pc:chgData name="정가영" userId="8dd6b78c-8fdb-47ca-9782-fb56b898c718" providerId="ADAL" clId="{932335E3-9B28-475D-829D-65FC9C058729}" dt="2024-03-19T04:48:56.347" v="1" actId="20577"/>
        <pc:sldMkLst>
          <pc:docMk/>
          <pc:sldMk cId="383289393" sldId="276"/>
        </pc:sldMkLst>
        <pc:spChg chg="mod">
          <ac:chgData name="정가영" userId="8dd6b78c-8fdb-47ca-9782-fb56b898c718" providerId="ADAL" clId="{932335E3-9B28-475D-829D-65FC9C058729}" dt="2024-03-19T04:48:56.347" v="1" actId="20577"/>
          <ac:spMkLst>
            <pc:docMk/>
            <pc:sldMk cId="383289393" sldId="276"/>
            <ac:spMk id="19" creationId="{2BDB48AB-A731-4AB1-4600-44F4EC86FEB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0083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7501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7476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682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2263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8134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867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7519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6427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820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955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9BBD6-568C-4434-92D6-BAC5E828051E}" type="datetimeFigureOut">
              <a:rPr lang="ko-KR" altLang="en-US" smtClean="0"/>
              <a:t>2024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67B6E-E976-4622-B767-50E1812D29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0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9.emf"/><Relationship Id="rId4" Type="http://schemas.openxmlformats.org/officeDocument/2006/relationships/image" Target="../media/image6.png"/><Relationship Id="rId9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2BDB48AB-A731-4AB1-4600-44F4EC86FEBE}"/>
              </a:ext>
            </a:extLst>
          </p:cNvPr>
          <p:cNvSpPr txBox="1"/>
          <p:nvPr/>
        </p:nvSpPr>
        <p:spPr>
          <a:xfrm>
            <a:off x="292918" y="8159867"/>
            <a:ext cx="61504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1. Selected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eptic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eptides used for HDX analysis.</a:t>
            </a: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elected peptic peptides used for HDX analysis of G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1 (A), G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q (B), an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(C). Blue bars represent peptic peptides.</a:t>
            </a:r>
          </a:p>
        </p:txBody>
      </p:sp>
      <p:pic>
        <p:nvPicPr>
          <p:cNvPr id="5" name="그림 4" descr="스크린샷, 다채로움, 일렉트릭 블루, 마조렐 블루이(가) 표시된 사진&#10;&#10;자동 생성된 설명">
            <a:extLst>
              <a:ext uri="{FF2B5EF4-FFF2-40B4-BE49-F238E27FC236}">
                <a16:creationId xmlns:a16="http://schemas.microsoft.com/office/drawing/2014/main" id="{41D5A0CE-F828-44EC-DADC-498DA6A3DC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09" y="576159"/>
            <a:ext cx="6012180" cy="2130831"/>
          </a:xfrm>
          <a:prstGeom prst="rect">
            <a:avLst/>
          </a:prstGeom>
        </p:spPr>
      </p:pic>
      <p:pic>
        <p:nvPicPr>
          <p:cNvPr id="7" name="그림 6" descr="스크린샷, 다채로움, 일렉트릭 블루, 마조렐 블루이(가) 표시된 사진&#10;&#10;자동 생성된 설명">
            <a:extLst>
              <a:ext uri="{FF2B5EF4-FFF2-40B4-BE49-F238E27FC236}">
                <a16:creationId xmlns:a16="http://schemas.microsoft.com/office/drawing/2014/main" id="{490B2873-778C-791E-C268-4D2AD8C54E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09" y="2938987"/>
            <a:ext cx="6012180" cy="248417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DA58F61-22B6-9B8D-57BF-B40B22C980E2}"/>
              </a:ext>
            </a:extLst>
          </p:cNvPr>
          <p:cNvSpPr txBox="1"/>
          <p:nvPr/>
        </p:nvSpPr>
        <p:spPr>
          <a:xfrm>
            <a:off x="-22510" y="456814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141752-D34A-3EA3-D497-0F727B0A3B2D}"/>
              </a:ext>
            </a:extLst>
          </p:cNvPr>
          <p:cNvSpPr txBox="1"/>
          <p:nvPr/>
        </p:nvSpPr>
        <p:spPr>
          <a:xfrm>
            <a:off x="-22510" y="2848351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3983B0-2366-5672-3032-88A8D36FE4A4}"/>
              </a:ext>
            </a:extLst>
          </p:cNvPr>
          <p:cNvSpPr txBox="1"/>
          <p:nvPr/>
        </p:nvSpPr>
        <p:spPr>
          <a:xfrm>
            <a:off x="-22510" y="5597977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 descr="스크린샷, 다채로움, 일렉트릭 블루, 블루이(가) 표시된 사진&#10;&#10;자동 생성된 설명">
            <a:extLst>
              <a:ext uri="{FF2B5EF4-FFF2-40B4-BE49-F238E27FC236}">
                <a16:creationId xmlns:a16="http://schemas.microsoft.com/office/drawing/2014/main" id="{FBBE3AC5-83CD-DFE3-0896-027EDC6DB35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09" y="5655155"/>
            <a:ext cx="6012000" cy="2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0487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2BDB48AB-A731-4AB1-4600-44F4EC86FEBE}"/>
              </a:ext>
            </a:extLst>
          </p:cNvPr>
          <p:cNvSpPr txBox="1"/>
          <p:nvPr/>
        </p:nvSpPr>
        <p:spPr>
          <a:xfrm>
            <a:off x="14560" y="7570769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2. The role of ICL2 in GPCR-G protein coupling.</a:t>
            </a: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A-C) The interaction of ICL2 of β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-hydrophobic pocket of Gαs (A), ICL2 of 5-H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-hydrophobic pocket Gαq (B) and ICL2 of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μO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hydrophobic pocket of Gαi1 (C). Selected residues are represented as sticks on the crystal structures of β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-Gs (PDB: 3SN6), 5-H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-Gq (PDB: 6WHA), and μOR-Gi1 (PDB: 6DDF). Receptors are colored green and Gα is colored orange. Residue 34.51 of receptors are colored magenta and residues encompassing hydrophobic pocket are colored orange. (D-F) The proportion of residue 34.50 (D), 34.52 (E), and 34.53 (F) in ICL2 of class A GPCRs.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2B7218E3-95B7-CFA5-50EB-EACB14772B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4194"/>
            <a:ext cx="2190750" cy="1759172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88603AE1-BC7D-A085-D9DC-F7253312F1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3625" y="674194"/>
            <a:ext cx="2190750" cy="1759172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890FD6AF-C91F-B5AE-F59C-D8BBFC9092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7250" y="674194"/>
            <a:ext cx="2190750" cy="17591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F258DF5-FB1A-EE36-B43C-67AB6B7953FC}"/>
              </a:ext>
            </a:extLst>
          </p:cNvPr>
          <p:cNvSpPr txBox="1"/>
          <p:nvPr/>
        </p:nvSpPr>
        <p:spPr>
          <a:xfrm>
            <a:off x="-22511" y="369047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BAB3D9-E30B-DC68-4C99-AAE10F8AF045}"/>
              </a:ext>
            </a:extLst>
          </p:cNvPr>
          <p:cNvSpPr txBox="1"/>
          <p:nvPr/>
        </p:nvSpPr>
        <p:spPr>
          <a:xfrm>
            <a:off x="2213786" y="362172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79C835-6402-8EAA-D347-18DD200ECC71}"/>
              </a:ext>
            </a:extLst>
          </p:cNvPr>
          <p:cNvSpPr txBox="1"/>
          <p:nvPr/>
        </p:nvSpPr>
        <p:spPr>
          <a:xfrm>
            <a:off x="4534772" y="370040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F4F222-001D-D5A7-3958-B1699525DC3D}"/>
              </a:ext>
            </a:extLst>
          </p:cNvPr>
          <p:cNvSpPr txBox="1"/>
          <p:nvPr/>
        </p:nvSpPr>
        <p:spPr>
          <a:xfrm>
            <a:off x="-22511" y="2571798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2D8434A6-1924-3353-CB42-C433E192AA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0713206"/>
              </p:ext>
            </p:extLst>
          </p:nvPr>
        </p:nvGraphicFramePr>
        <p:xfrm>
          <a:off x="161925" y="2511425"/>
          <a:ext cx="3236913" cy="2697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593434" imgH="2996121" progId="Prism9.Document">
                  <p:embed/>
                </p:oleObj>
              </mc:Choice>
              <mc:Fallback>
                <p:oleObj name="Prism 9" r:id="rId5" imgW="3593434" imgH="2996121" progId="Prism9.Document">
                  <p:embed/>
                  <p:pic>
                    <p:nvPicPr>
                      <p:cNvPr id="16" name="개체 15">
                        <a:extLst>
                          <a:ext uri="{FF2B5EF4-FFF2-40B4-BE49-F238E27FC236}">
                            <a16:creationId xmlns:a16="http://schemas.microsoft.com/office/drawing/2014/main" id="{2D8434A6-1924-3353-CB42-C433E192AA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1925" y="2511425"/>
                        <a:ext cx="3236913" cy="2697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B4CD90ED-70F1-8648-FFC7-36B4ECD47D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0901528"/>
              </p:ext>
            </p:extLst>
          </p:nvPr>
        </p:nvGraphicFramePr>
        <p:xfrm>
          <a:off x="3425825" y="2513013"/>
          <a:ext cx="3213100" cy="2728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570385" imgH="3033938" progId="Prism9.Document">
                  <p:embed/>
                </p:oleObj>
              </mc:Choice>
              <mc:Fallback>
                <p:oleObj name="Prism 9" r:id="rId7" imgW="3570385" imgH="3033938" progId="Prism9.Document">
                  <p:embed/>
                  <p:pic>
                    <p:nvPicPr>
                      <p:cNvPr id="18" name="개체 17">
                        <a:extLst>
                          <a:ext uri="{FF2B5EF4-FFF2-40B4-BE49-F238E27FC236}">
                            <a16:creationId xmlns:a16="http://schemas.microsoft.com/office/drawing/2014/main" id="{B4CD90ED-70F1-8648-FFC7-36B4ECD47D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25825" y="2513013"/>
                        <a:ext cx="3213100" cy="2728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개체 25">
            <a:extLst>
              <a:ext uri="{FF2B5EF4-FFF2-40B4-BE49-F238E27FC236}">
                <a16:creationId xmlns:a16="http://schemas.microsoft.com/office/drawing/2014/main" id="{423DB5BA-4B19-EA35-93BD-2315085834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8944653"/>
              </p:ext>
            </p:extLst>
          </p:nvPr>
        </p:nvGraphicFramePr>
        <p:xfrm>
          <a:off x="163513" y="5033963"/>
          <a:ext cx="3216275" cy="2733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570385" imgH="3033938" progId="Prism9.Document">
                  <p:embed/>
                </p:oleObj>
              </mc:Choice>
              <mc:Fallback>
                <p:oleObj name="Prism 9" r:id="rId9" imgW="3570385" imgH="3033938" progId="Prism9.Document">
                  <p:embed/>
                  <p:pic>
                    <p:nvPicPr>
                      <p:cNvPr id="26" name="개체 25">
                        <a:extLst>
                          <a:ext uri="{FF2B5EF4-FFF2-40B4-BE49-F238E27FC236}">
                            <a16:creationId xmlns:a16="http://schemas.microsoft.com/office/drawing/2014/main" id="{423DB5BA-4B19-EA35-93BD-2315085834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63513" y="5033963"/>
                        <a:ext cx="3216275" cy="2733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542BF94D-ADCC-DAB6-9AD5-303180BDE3FD}"/>
              </a:ext>
            </a:extLst>
          </p:cNvPr>
          <p:cNvSpPr txBox="1"/>
          <p:nvPr/>
        </p:nvSpPr>
        <p:spPr>
          <a:xfrm>
            <a:off x="3201428" y="2571798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880E990-70D8-6FE6-3D62-239922C33E8E}"/>
              </a:ext>
            </a:extLst>
          </p:cNvPr>
          <p:cNvSpPr txBox="1"/>
          <p:nvPr/>
        </p:nvSpPr>
        <p:spPr>
          <a:xfrm>
            <a:off x="-22511" y="5066224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893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D8408498-C13C-0937-17F6-DD13C6B92830}"/>
              </a:ext>
            </a:extLst>
          </p:cNvPr>
          <p:cNvSpPr txBox="1"/>
          <p:nvPr/>
        </p:nvSpPr>
        <p:spPr>
          <a:xfrm>
            <a:off x="-94145" y="973532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5F535B7-A9BA-568C-95C8-BD776434F715}"/>
              </a:ext>
            </a:extLst>
          </p:cNvPr>
          <p:cNvSpPr txBox="1"/>
          <p:nvPr/>
        </p:nvSpPr>
        <p:spPr>
          <a:xfrm>
            <a:off x="3177140" y="973532"/>
            <a:ext cx="50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1798889D-BB28-C3A9-595B-59F9B2D720CD}"/>
              </a:ext>
            </a:extLst>
          </p:cNvPr>
          <p:cNvGrpSpPr/>
          <p:nvPr/>
        </p:nvGrpSpPr>
        <p:grpSpPr>
          <a:xfrm>
            <a:off x="118440" y="1070832"/>
            <a:ext cx="3310561" cy="3228060"/>
            <a:chOff x="118440" y="1539462"/>
            <a:chExt cx="3310561" cy="3228060"/>
          </a:xfrm>
        </p:grpSpPr>
        <p:pic>
          <p:nvPicPr>
            <p:cNvPr id="9" name="그림 8" descr="스크린샷, 예술, 그래픽 디자인, 디자인이(가) 표시된 사진&#10;&#10;자동 생성된 설명">
              <a:extLst>
                <a:ext uri="{FF2B5EF4-FFF2-40B4-BE49-F238E27FC236}">
                  <a16:creationId xmlns:a16="http://schemas.microsoft.com/office/drawing/2014/main" id="{9BFFAF96-6C3C-4756-D00C-EACE1B8E49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73" r="31871"/>
            <a:stretch/>
          </p:blipFill>
          <p:spPr>
            <a:xfrm>
              <a:off x="118440" y="1539462"/>
              <a:ext cx="3310561" cy="313076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E4B695E-B021-5A86-9DCD-682EB02F7F8F}"/>
                </a:ext>
              </a:extLst>
            </p:cNvPr>
            <p:cNvSpPr txBox="1"/>
            <p:nvPr/>
          </p:nvSpPr>
          <p:spPr>
            <a:xfrm>
              <a:off x="118440" y="3878368"/>
              <a:ext cx="1622560" cy="889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200" b="1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-coupled </a:t>
              </a:r>
              <a:r>
                <a:rPr lang="en-US" altLang="ko-KR" sz="12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s</a:t>
              </a:r>
              <a:endPara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rgbClr val="60F7F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2-coupled </a:t>
              </a:r>
              <a:r>
                <a:rPr lang="en-US" altLang="ko-KR" sz="1200" b="1" dirty="0" err="1">
                  <a:solidFill>
                    <a:srgbClr val="60F7F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A</a:t>
              </a:r>
              <a:endParaRPr lang="en-US" altLang="ko-KR" sz="1200" b="1" dirty="0">
                <a:solidFill>
                  <a:srgbClr val="60F7F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chemeClr val="accent5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T</a:t>
              </a:r>
              <a:r>
                <a:rPr lang="en-US" altLang="ko-KR" sz="1200" b="1" baseline="-25000" dirty="0">
                  <a:solidFill>
                    <a:schemeClr val="accent5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altLang="ko-KR" sz="1200" b="1" dirty="0">
                  <a:solidFill>
                    <a:schemeClr val="accent5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oupled Gi1</a:t>
              </a:r>
              <a:endParaRPr lang="ko-KR" altLang="en-US" sz="12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C9F94691-D5EA-3D64-EDFB-7A36ABFCB93D}"/>
              </a:ext>
            </a:extLst>
          </p:cNvPr>
          <p:cNvGrpSpPr/>
          <p:nvPr/>
        </p:nvGrpSpPr>
        <p:grpSpPr>
          <a:xfrm>
            <a:off x="3467429" y="1070832"/>
            <a:ext cx="3310561" cy="3228060"/>
            <a:chOff x="3547439" y="1539462"/>
            <a:chExt cx="3310561" cy="3228060"/>
          </a:xfrm>
        </p:grpSpPr>
        <p:pic>
          <p:nvPicPr>
            <p:cNvPr id="10" name="그림 9" descr="스크린샷, 그래픽 디자인, 어둠, 그래픽이(가) 표시된 사진&#10;&#10;자동 생성된 설명">
              <a:extLst>
                <a:ext uri="{FF2B5EF4-FFF2-40B4-BE49-F238E27FC236}">
                  <a16:creationId xmlns:a16="http://schemas.microsoft.com/office/drawing/2014/main" id="{00CE3D9F-6E87-BE4A-032A-80C17B94F9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73" r="31872"/>
            <a:stretch/>
          </p:blipFill>
          <p:spPr>
            <a:xfrm>
              <a:off x="3547439" y="1539462"/>
              <a:ext cx="3310561" cy="313076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7A39996-A31E-A3DA-F9EC-3CE6FDDCEB19}"/>
                </a:ext>
              </a:extLst>
            </p:cNvPr>
            <p:cNvSpPr txBox="1"/>
            <p:nvPr/>
          </p:nvSpPr>
          <p:spPr>
            <a:xfrm>
              <a:off x="3580159" y="3878368"/>
              <a:ext cx="1622560" cy="889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200" b="1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-coupled </a:t>
              </a:r>
              <a:r>
                <a:rPr lang="en-US" altLang="ko-KR" sz="12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s</a:t>
              </a:r>
              <a:endPara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3-coupled </a:t>
              </a:r>
              <a:r>
                <a:rPr lang="en-US" altLang="ko-KR" sz="1200" b="1" dirty="0" err="1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q</a:t>
              </a:r>
              <a:endParaRPr lang="en-US" altLang="ko-KR" sz="12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lnSpc>
                  <a:spcPct val="150000"/>
                </a:lnSpc>
                <a:buFont typeface="Wingdings" panose="05000000000000000000" pitchFamily="2" charset="2"/>
                <a:buChar char="§"/>
              </a:pPr>
              <a:r>
                <a:rPr lang="en-US" altLang="ko-KR" sz="1200" b="1" dirty="0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T</a:t>
              </a:r>
              <a:r>
                <a:rPr lang="en-US" altLang="ko-KR" sz="1200" b="1" baseline="-25000" dirty="0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altLang="ko-KR" sz="1200" b="1" dirty="0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oupled </a:t>
              </a:r>
              <a:r>
                <a:rPr lang="en-US" altLang="ko-KR" sz="1200" b="1" dirty="0" err="1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q</a:t>
              </a:r>
              <a:endParaRPr lang="ko-KR" altLang="en-US" sz="1200" b="1" dirty="0">
                <a:solidFill>
                  <a:srgbClr val="FF99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화살표: 위로 구부러짐 14">
            <a:extLst>
              <a:ext uri="{FF2B5EF4-FFF2-40B4-BE49-F238E27FC236}">
                <a16:creationId xmlns:a16="http://schemas.microsoft.com/office/drawing/2014/main" id="{578C3924-D9DD-BACB-7AD3-FE13CFA08786}"/>
              </a:ext>
            </a:extLst>
          </p:cNvPr>
          <p:cNvSpPr/>
          <p:nvPr/>
        </p:nvSpPr>
        <p:spPr>
          <a:xfrm>
            <a:off x="5518150" y="3212172"/>
            <a:ext cx="381000" cy="138218"/>
          </a:xfrm>
          <a:prstGeom prst="curvedUp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B0BA2F4-E49E-BCFA-2497-4692F75BF2CB}"/>
              </a:ext>
            </a:extLst>
          </p:cNvPr>
          <p:cNvSpPr txBox="1"/>
          <p:nvPr/>
        </p:nvSpPr>
        <p:spPr>
          <a:xfrm>
            <a:off x="118440" y="5049174"/>
            <a:ext cx="665955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3. The orientation of GPCR-G protein complex and the interaction between ICL2 and hydrophobic pocket in G</a:t>
            </a:r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α. </a:t>
            </a:r>
            <a:endParaRPr lang="en-US" altLang="ko-K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) Superposition of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l-GR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-Gs (PDB: 3SN6), M2-GoA (PDB: 6OIK), an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Gi1 (PDB: 8HBD). (B) Superposition of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-Gs (PDB: 3SN6), M3-Gq (8E9Z), an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q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(PDB: 8HCX). GPCR-G protein complexes were aligned using the receptors.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l-GR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 and M2 are colored grey. Gi1-couple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light purple,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q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couple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white.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l-GR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-couple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red, M2-couple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o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cyan, M3-couple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q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orange,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coupled Gi1 is colored light cyan, and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couple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q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light pink. F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4.5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l-GR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, L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4.5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f M2/M3, and W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4.50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f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green. S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4.5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f ET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colored magenta.</a:t>
            </a:r>
          </a:p>
        </p:txBody>
      </p:sp>
    </p:spTree>
    <p:extLst>
      <p:ext uri="{BB962C8B-B14F-4D97-AF65-F5344CB8AC3E}">
        <p14:creationId xmlns:p14="http://schemas.microsoft.com/office/powerpoint/2010/main" val="594898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37</TotalTime>
  <Words>356</Words>
  <Application>Microsoft Office PowerPoint</Application>
  <PresentationFormat>Letter 용지(8.5x11in)</PresentationFormat>
  <Paragraphs>23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Wingdings</vt:lpstr>
      <vt:lpstr>Office 테마</vt:lpstr>
      <vt:lpstr>GraphPad Prism 9 Project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Young</dc:creator>
  <cp:lastModifiedBy>정가영</cp:lastModifiedBy>
  <cp:revision>36</cp:revision>
  <dcterms:created xsi:type="dcterms:W3CDTF">2022-03-28T04:42:04Z</dcterms:created>
  <dcterms:modified xsi:type="dcterms:W3CDTF">2024-03-20T05:59:18Z</dcterms:modified>
</cp:coreProperties>
</file>